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943" r:id="rId2"/>
    <p:sldId id="944" r:id="rId3"/>
    <p:sldId id="945" r:id="rId4"/>
    <p:sldId id="929" r:id="rId5"/>
    <p:sldId id="946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6330"/>
    <a:srgbClr val="09FCF5"/>
    <a:srgbClr val="ED01FE"/>
    <a:srgbClr val="DFF8FF"/>
    <a:srgbClr val="BEE7FB"/>
    <a:srgbClr val="BEE7C9"/>
    <a:srgbClr val="FFBAB6"/>
    <a:srgbClr val="FFFFC2"/>
    <a:srgbClr val="AB4FF2"/>
    <a:srgbClr val="F6B1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14"/>
    <p:restoredTop sz="95226" autoAdjust="0"/>
  </p:normalViewPr>
  <p:slideViewPr>
    <p:cSldViewPr snapToGrid="0">
      <p:cViewPr varScale="1">
        <p:scale>
          <a:sx n="75" d="100"/>
          <a:sy n="75" d="100"/>
        </p:scale>
        <p:origin x="3288" y="72"/>
      </p:cViewPr>
      <p:guideLst/>
    </p:cSldViewPr>
  </p:slideViewPr>
  <p:outlineViewPr>
    <p:cViewPr>
      <p:scale>
        <a:sx n="100" d="100"/>
        <a:sy n="100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E385D9-0391-7544-B938-EB35D4706647}" type="datetimeFigureOut">
              <a:rPr lang="en-NP" smtClean="0"/>
              <a:t>04/02/2024</a:t>
            </a:fld>
            <a:endParaRPr lang="en-N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6FA8DA-8C2C-0940-81F9-2D4E305E0F15}" type="slidenum">
              <a:rPr lang="en-NP" smtClean="0"/>
              <a:t>‹#›</a:t>
            </a:fld>
            <a:endParaRPr lang="en-NP"/>
          </a:p>
        </p:txBody>
      </p:sp>
    </p:spTree>
    <p:extLst>
      <p:ext uri="{BB962C8B-B14F-4D97-AF65-F5344CB8AC3E}">
        <p14:creationId xmlns:p14="http://schemas.microsoft.com/office/powerpoint/2010/main" val="704371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F1E2A0-47A4-D364-649F-1526038C22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92D659D-5E38-7D0B-7563-C932C8069A4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CE8F9D7-8ADB-4FB7-CDC1-F808B10831F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P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1977E7-E241-1339-42CD-AD859943E77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6FA8DA-8C2C-0940-81F9-2D4E305E0F15}" type="slidenum">
              <a:rPr lang="en-NP" smtClean="0"/>
              <a:t>1</a:t>
            </a:fld>
            <a:endParaRPr lang="en-NP"/>
          </a:p>
        </p:txBody>
      </p:sp>
    </p:spTree>
    <p:extLst>
      <p:ext uri="{BB962C8B-B14F-4D97-AF65-F5344CB8AC3E}">
        <p14:creationId xmlns:p14="http://schemas.microsoft.com/office/powerpoint/2010/main" val="318351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1AEFDC-B224-0B9E-33BD-AACFFE0F1A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B8394C4-EC6F-C8EA-3B2E-4B6A43895B9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2D0DD15-3BA3-8440-E57C-BD562B24C7F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P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B1525C-6B80-5224-FADA-988F2F93C18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6FA8DA-8C2C-0940-81F9-2D4E305E0F15}" type="slidenum">
              <a:rPr lang="en-NP" smtClean="0"/>
              <a:t>2</a:t>
            </a:fld>
            <a:endParaRPr lang="en-NP"/>
          </a:p>
        </p:txBody>
      </p:sp>
    </p:spTree>
    <p:extLst>
      <p:ext uri="{BB962C8B-B14F-4D97-AF65-F5344CB8AC3E}">
        <p14:creationId xmlns:p14="http://schemas.microsoft.com/office/powerpoint/2010/main" val="25403182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FEC56ED-CABA-F92E-D4BC-62074B8815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31C4FB4-C854-A84E-9376-A1160261626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76795B2-3566-9E77-4220-710735170C2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P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6175E3-4697-D96F-C9B1-98160EC9EB3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6FA8DA-8C2C-0940-81F9-2D4E305E0F15}" type="slidenum">
              <a:rPr lang="en-NP" smtClean="0"/>
              <a:t>3</a:t>
            </a:fld>
            <a:endParaRPr lang="en-NP"/>
          </a:p>
        </p:txBody>
      </p:sp>
    </p:spTree>
    <p:extLst>
      <p:ext uri="{BB962C8B-B14F-4D97-AF65-F5344CB8AC3E}">
        <p14:creationId xmlns:p14="http://schemas.microsoft.com/office/powerpoint/2010/main" val="15391704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01386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20811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45876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1044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72925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34181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5345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80762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60306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80399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126027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9C9FF-A612-1A42-9862-74BB724142DF}" type="datetimeFigureOut">
              <a:rPr lang="en-JP" smtClean="0"/>
              <a:t>04/02/202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E0DEA-8675-024F-8455-44EB246B0EE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61490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Relationship Id="rId14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10" Type="http://schemas.openxmlformats.org/officeDocument/2006/relationships/image" Target="../media/image32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67E62C9-4940-C1A0-0011-F9B2DA9D5B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062DC4F3-CDC4-045D-10CF-1BDEDF69F0E0}"/>
              </a:ext>
            </a:extLst>
          </p:cNvPr>
          <p:cNvGrpSpPr/>
          <p:nvPr/>
        </p:nvGrpSpPr>
        <p:grpSpPr>
          <a:xfrm>
            <a:off x="4435" y="8197"/>
            <a:ext cx="2370755" cy="9281157"/>
            <a:chOff x="-95148" y="-2308283"/>
            <a:chExt cx="2370755" cy="9281157"/>
          </a:xfrm>
        </p:grpSpPr>
        <p:pic>
          <p:nvPicPr>
            <p:cNvPr id="5" name="Picture 4" descr="A graph with a red line and blue dots&#10;&#10;Description automatically generated">
              <a:extLst>
                <a:ext uri="{FF2B5EF4-FFF2-40B4-BE49-F238E27FC236}">
                  <a16:creationId xmlns:a16="http://schemas.microsoft.com/office/drawing/2014/main" id="{53E5848A-8395-BE78-2D7E-B33BEA7EE6A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-37827" y="18421"/>
              <a:ext cx="2276386" cy="2297391"/>
            </a:xfrm>
            <a:prstGeom prst="rect">
              <a:avLst/>
            </a:prstGeom>
          </p:spPr>
        </p:pic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A97012F0-A73F-2F21-6AA5-2892CA69DF2D}"/>
                </a:ext>
              </a:extLst>
            </p:cNvPr>
            <p:cNvGrpSpPr/>
            <p:nvPr/>
          </p:nvGrpSpPr>
          <p:grpSpPr>
            <a:xfrm>
              <a:off x="-95148" y="-2308283"/>
              <a:ext cx="2370755" cy="9281157"/>
              <a:chOff x="-3288032" y="-5473183"/>
              <a:chExt cx="2370755" cy="9281157"/>
            </a:xfrm>
          </p:grpSpPr>
          <p:pic>
            <p:nvPicPr>
              <p:cNvPr id="145" name="Picture 144" descr="A graph with a line and numbers&#10;&#10;Description automatically generated">
                <a:extLst>
                  <a:ext uri="{FF2B5EF4-FFF2-40B4-BE49-F238E27FC236}">
                    <a16:creationId xmlns:a16="http://schemas.microsoft.com/office/drawing/2014/main" id="{D25A1828-2428-67DE-6F80-7338369676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alphaModFix/>
              </a:blip>
              <a:stretch>
                <a:fillRect/>
              </a:stretch>
            </p:blipFill>
            <p:spPr>
              <a:xfrm>
                <a:off x="-3280411" y="-5473183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56" name="Picture 155" descr="A graph with numbers and a red line&#10;&#10;Description automatically generated">
                <a:extLst>
                  <a:ext uri="{FF2B5EF4-FFF2-40B4-BE49-F238E27FC236}">
                    <a16:creationId xmlns:a16="http://schemas.microsoft.com/office/drawing/2014/main" id="{B2D206EF-CB83-FA83-B16B-23670B0AA0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-3288032" y="1487464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23" name="Picture 122" descr="A graph with a red line and a blue circle&#10;&#10;Description automatically generated">
                <a:extLst>
                  <a:ext uri="{FF2B5EF4-FFF2-40B4-BE49-F238E27FC236}">
                    <a16:creationId xmlns:a16="http://schemas.microsoft.com/office/drawing/2014/main" id="{46CDC761-B381-E85A-B92A-D4896EEDEE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-3237787" y="-838282"/>
                <a:ext cx="2320510" cy="2320510"/>
              </a:xfrm>
              <a:prstGeom prst="rect">
                <a:avLst/>
              </a:prstGeom>
            </p:spPr>
          </p:pic>
        </p:grp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0DE983DB-0795-1061-55D6-A8215E7E4759}"/>
              </a:ext>
            </a:extLst>
          </p:cNvPr>
          <p:cNvSpPr txBox="1"/>
          <p:nvPr/>
        </p:nvSpPr>
        <p:spPr>
          <a:xfrm>
            <a:off x="-43404" y="9204522"/>
            <a:ext cx="699726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P" sz="1000" b="1" dirty="0"/>
              <a:t>Figure S1.</a:t>
            </a:r>
            <a:r>
              <a:rPr lang="en-NP" sz="1000" dirty="0"/>
              <a:t> </a:t>
            </a:r>
            <a:r>
              <a:rPr lang="en-US" sz="1000" dirty="0"/>
              <a:t>Regression and correlation assessment of the putative </a:t>
            </a:r>
            <a:r>
              <a:rPr lang="en-US" sz="1000" i="1" dirty="0"/>
              <a:t>MYB98</a:t>
            </a:r>
            <a:r>
              <a:rPr lang="en-US" sz="1000" dirty="0"/>
              <a:t> expression regulating transcription factors (TFs). Each plot represents correlation/regression to individual TF. The plots are arranged from the highest (with positive regression) to the lowest (with negative regression) R</a:t>
            </a:r>
            <a:r>
              <a:rPr lang="en-US" sz="1000" baseline="30000" dirty="0"/>
              <a:t>2</a:t>
            </a:r>
            <a:r>
              <a:rPr lang="en-US" sz="1000" dirty="0"/>
              <a:t>-value. </a:t>
            </a:r>
            <a:r>
              <a:rPr lang="en-US" sz="1000" i="1" dirty="0"/>
              <a:t>MYB98</a:t>
            </a:r>
            <a:r>
              <a:rPr lang="en-US" sz="1000" dirty="0"/>
              <a:t> was plotted against itself for the very first plot as a positive control. (</a:t>
            </a:r>
            <a:r>
              <a:rPr lang="en-US" sz="1000" i="1" dirty="0"/>
              <a:t>Data source: </a:t>
            </a:r>
            <a:r>
              <a:rPr lang="en-US" sz="1000" dirty="0"/>
              <a:t>ATTED-II (Obayashi et al., 2022))</a:t>
            </a:r>
            <a:endParaRPr lang="en-NP" sz="1000" dirty="0">
              <a:solidFill>
                <a:srgbClr val="FF0000"/>
              </a:solidFill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778AEF8C-1791-8E0D-3AAF-521D3825779C}"/>
              </a:ext>
            </a:extLst>
          </p:cNvPr>
          <p:cNvGrpSpPr/>
          <p:nvPr/>
        </p:nvGrpSpPr>
        <p:grpSpPr>
          <a:xfrm>
            <a:off x="2261927" y="9056"/>
            <a:ext cx="2365720" cy="9280642"/>
            <a:chOff x="2180450" y="-2307424"/>
            <a:chExt cx="2365720" cy="9280642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89EF98F-BA92-6D44-F7A2-FD5784F9D4EF}"/>
                </a:ext>
              </a:extLst>
            </p:cNvPr>
            <p:cNvGrpSpPr/>
            <p:nvPr/>
          </p:nvGrpSpPr>
          <p:grpSpPr>
            <a:xfrm>
              <a:off x="2180450" y="13196"/>
              <a:ext cx="2365720" cy="6960022"/>
              <a:chOff x="-3226623" y="6129720"/>
              <a:chExt cx="2365720" cy="6960022"/>
            </a:xfrm>
          </p:grpSpPr>
          <p:pic>
            <p:nvPicPr>
              <p:cNvPr id="158" name="Picture 157" descr="A graph with a red line and a blue circle&#10;&#10;Description automatically generated">
                <a:extLst>
                  <a:ext uri="{FF2B5EF4-FFF2-40B4-BE49-F238E27FC236}">
                    <a16:creationId xmlns:a16="http://schemas.microsoft.com/office/drawing/2014/main" id="{392F0514-D7C2-AA7A-4E0F-6BC5AFF478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-3226623" y="8448367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62" name="Picture 161" descr="A graph with a red line and blue dots&#10;&#10;Description automatically generated">
                <a:extLst>
                  <a:ext uri="{FF2B5EF4-FFF2-40B4-BE49-F238E27FC236}">
                    <a16:creationId xmlns:a16="http://schemas.microsoft.com/office/drawing/2014/main" id="{EB2CF103-4B69-CCFD-E188-A90E2C75E3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-3184501" y="6129720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63" name="Picture 162" descr="A graph with a blue circle with a red line&#10;&#10;Description automatically generated">
                <a:extLst>
                  <a:ext uri="{FF2B5EF4-FFF2-40B4-BE49-F238E27FC236}">
                    <a16:creationId xmlns:a16="http://schemas.microsoft.com/office/drawing/2014/main" id="{2350BA4F-83C7-B3FC-3789-F9B5D43ADD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-3181413" y="10769232"/>
                <a:ext cx="2320510" cy="2320510"/>
              </a:xfrm>
              <a:prstGeom prst="rect">
                <a:avLst/>
              </a:prstGeom>
            </p:spPr>
          </p:pic>
        </p:grpSp>
        <p:pic>
          <p:nvPicPr>
            <p:cNvPr id="6" name="Picture 5" descr="A graph of a blue circle with a red line&#10;&#10;Description automatically generated">
              <a:extLst>
                <a:ext uri="{FF2B5EF4-FFF2-40B4-BE49-F238E27FC236}">
                  <a16:creationId xmlns:a16="http://schemas.microsoft.com/office/drawing/2014/main" id="{EEAC675A-28D9-A1D3-2592-3AA494F666B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alphaModFix/>
            </a:blip>
            <a:stretch>
              <a:fillRect/>
            </a:stretch>
          </p:blipFill>
          <p:spPr>
            <a:xfrm>
              <a:off x="2222572" y="-2307424"/>
              <a:ext cx="2320510" cy="2320510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F288F20-375F-D2A7-C7CE-4F47114AEE34}"/>
              </a:ext>
            </a:extLst>
          </p:cNvPr>
          <p:cNvGrpSpPr/>
          <p:nvPr/>
        </p:nvGrpSpPr>
        <p:grpSpPr>
          <a:xfrm>
            <a:off x="4478227" y="6589"/>
            <a:ext cx="2375378" cy="9286983"/>
            <a:chOff x="4442015" y="-2309891"/>
            <a:chExt cx="2375378" cy="9286983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51B0A4C-6003-6E1A-72EE-A1BFAF4BA216}"/>
                </a:ext>
              </a:extLst>
            </p:cNvPr>
            <p:cNvGrpSpPr/>
            <p:nvPr/>
          </p:nvGrpSpPr>
          <p:grpSpPr>
            <a:xfrm>
              <a:off x="4442015" y="13196"/>
              <a:ext cx="2374637" cy="6963896"/>
              <a:chOff x="-939169" y="1484188"/>
              <a:chExt cx="2374637" cy="6963896"/>
            </a:xfrm>
          </p:grpSpPr>
          <p:pic>
            <p:nvPicPr>
              <p:cNvPr id="164" name="Picture 163" descr="A graph with a red line and blue dots&#10;&#10;Description automatically generated">
                <a:extLst>
                  <a:ext uri="{FF2B5EF4-FFF2-40B4-BE49-F238E27FC236}">
                    <a16:creationId xmlns:a16="http://schemas.microsoft.com/office/drawing/2014/main" id="{6C11F9B1-046B-2C62-D290-A5DF344496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-885042" y="1484188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66" name="Picture 165" descr="A graph with a blue circle with a red line&#10;&#10;Description automatically generated">
                <a:extLst>
                  <a:ext uri="{FF2B5EF4-FFF2-40B4-BE49-F238E27FC236}">
                    <a16:creationId xmlns:a16="http://schemas.microsoft.com/office/drawing/2014/main" id="{0A2604A4-C7BD-C2CE-4897-0F8FC2C5EF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-939169" y="3803995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67" name="Picture 166" descr="A diagram of a blue ball with a red line&#10;&#10;Description automatically generated">
                <a:extLst>
                  <a:ext uri="{FF2B5EF4-FFF2-40B4-BE49-F238E27FC236}">
                    <a16:creationId xmlns:a16="http://schemas.microsoft.com/office/drawing/2014/main" id="{4013D8B6-A638-AEE1-7FB8-1E364811423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-928150" y="6127574"/>
                <a:ext cx="2320510" cy="2320510"/>
              </a:xfrm>
              <a:prstGeom prst="rect">
                <a:avLst/>
              </a:prstGeom>
            </p:spPr>
          </p:pic>
        </p:grpSp>
        <p:pic>
          <p:nvPicPr>
            <p:cNvPr id="7" name="Picture 6" descr="A graph with a red line and blue dots&#10;&#10;Description automatically generated">
              <a:extLst>
                <a:ext uri="{FF2B5EF4-FFF2-40B4-BE49-F238E27FC236}">
                  <a16:creationId xmlns:a16="http://schemas.microsoft.com/office/drawing/2014/main" id="{2A32615E-E710-27D6-B44C-1BDCA3512C6F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alphaModFix/>
            </a:blip>
            <a:stretch>
              <a:fillRect/>
            </a:stretch>
          </p:blipFill>
          <p:spPr>
            <a:xfrm>
              <a:off x="4496883" y="-2309891"/>
              <a:ext cx="2320510" cy="232051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62785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DC7A4E-845E-56C5-44F5-7D1C3FF754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0332AFE-54F7-BA83-A217-D304F85BD45F}"/>
              </a:ext>
            </a:extLst>
          </p:cNvPr>
          <p:cNvSpPr txBox="1"/>
          <p:nvPr/>
        </p:nvSpPr>
        <p:spPr>
          <a:xfrm>
            <a:off x="163915" y="9352002"/>
            <a:ext cx="67619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P" sz="1000" b="1" dirty="0"/>
              <a:t>Figure S1.</a:t>
            </a:r>
            <a:r>
              <a:rPr lang="en-NP" sz="1000" dirty="0"/>
              <a:t> </a:t>
            </a:r>
            <a:r>
              <a:rPr lang="en-US" sz="1000" dirty="0"/>
              <a:t>Continued….</a:t>
            </a:r>
            <a:endParaRPr lang="en-NP" sz="1000" dirty="0">
              <a:solidFill>
                <a:srgbClr val="FF0000"/>
              </a:solidFill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9BA673FE-14D8-A300-6419-309988917221}"/>
              </a:ext>
            </a:extLst>
          </p:cNvPr>
          <p:cNvGrpSpPr/>
          <p:nvPr/>
        </p:nvGrpSpPr>
        <p:grpSpPr>
          <a:xfrm>
            <a:off x="17740" y="77515"/>
            <a:ext cx="2385461" cy="9284230"/>
            <a:chOff x="-18472" y="-2299925"/>
            <a:chExt cx="2385461" cy="9284230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2412CC4B-F313-D95F-5363-A29110EB29AA}"/>
                </a:ext>
              </a:extLst>
            </p:cNvPr>
            <p:cNvGrpSpPr/>
            <p:nvPr/>
          </p:nvGrpSpPr>
          <p:grpSpPr>
            <a:xfrm>
              <a:off x="0" y="23966"/>
              <a:ext cx="2366989" cy="6960339"/>
              <a:chOff x="1462876" y="-3158791"/>
              <a:chExt cx="2366989" cy="6960339"/>
            </a:xfrm>
          </p:grpSpPr>
          <p:pic>
            <p:nvPicPr>
              <p:cNvPr id="89" name="Picture 88" descr="A graph with a red line&#10;&#10;Description automatically generated">
                <a:extLst>
                  <a:ext uri="{FF2B5EF4-FFF2-40B4-BE49-F238E27FC236}">
                    <a16:creationId xmlns:a16="http://schemas.microsoft.com/office/drawing/2014/main" id="{ACB735EF-37FE-E83F-A98D-173BE950E4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09355" y="-844708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08" name="Picture 107" descr="A graph with a blue circle with red line&#10;&#10;Description automatically generated">
                <a:extLst>
                  <a:ext uri="{FF2B5EF4-FFF2-40B4-BE49-F238E27FC236}">
                    <a16:creationId xmlns:a16="http://schemas.microsoft.com/office/drawing/2014/main" id="{92095521-8489-5A4E-5209-8C693E4A65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509355" y="-3158791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25" name="Picture 124" descr="A diagram of a blue circle with a red line&#10;&#10;Description automatically generated">
                <a:extLst>
                  <a:ext uri="{FF2B5EF4-FFF2-40B4-BE49-F238E27FC236}">
                    <a16:creationId xmlns:a16="http://schemas.microsoft.com/office/drawing/2014/main" id="{44096B23-3319-0F69-F39E-A3FF7DA354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462876" y="1481038"/>
                <a:ext cx="2320510" cy="2320510"/>
              </a:xfrm>
              <a:prstGeom prst="rect">
                <a:avLst/>
              </a:prstGeom>
            </p:spPr>
          </p:pic>
        </p:grpSp>
        <p:pic>
          <p:nvPicPr>
            <p:cNvPr id="2" name="Picture 1" descr="A graph with a red line&#10;&#10;Description automatically generated">
              <a:extLst>
                <a:ext uri="{FF2B5EF4-FFF2-40B4-BE49-F238E27FC236}">
                  <a16:creationId xmlns:a16="http://schemas.microsoft.com/office/drawing/2014/main" id="{8C15EB25-8514-4EAD-234D-0674C3B42A9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-18472" y="-2299925"/>
              <a:ext cx="2320510" cy="2320510"/>
            </a:xfrm>
            <a:prstGeom prst="rect">
              <a:avLst/>
            </a:prstGeom>
          </p:spPr>
        </p:pic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9B60D7D4-DB1E-BD4A-F801-019F5F7648B1}"/>
              </a:ext>
            </a:extLst>
          </p:cNvPr>
          <p:cNvGrpSpPr/>
          <p:nvPr/>
        </p:nvGrpSpPr>
        <p:grpSpPr>
          <a:xfrm>
            <a:off x="2269448" y="76093"/>
            <a:ext cx="2381651" cy="9288737"/>
            <a:chOff x="2197024" y="-2301347"/>
            <a:chExt cx="2381651" cy="9288737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751D3954-8D4F-BF36-6FE0-F4A93347A9F7}"/>
                </a:ext>
              </a:extLst>
            </p:cNvPr>
            <p:cNvGrpSpPr/>
            <p:nvPr/>
          </p:nvGrpSpPr>
          <p:grpSpPr>
            <a:xfrm>
              <a:off x="2197024" y="27463"/>
              <a:ext cx="2340636" cy="6959927"/>
              <a:chOff x="1446486" y="6128917"/>
              <a:chExt cx="2340636" cy="6959927"/>
            </a:xfrm>
          </p:grpSpPr>
          <p:pic>
            <p:nvPicPr>
              <p:cNvPr id="79" name="Picture 78" descr="A graph with a red line and a blue circle&#10;&#10;Description automatically generated">
                <a:extLst>
                  <a:ext uri="{FF2B5EF4-FFF2-40B4-BE49-F238E27FC236}">
                    <a16:creationId xmlns:a16="http://schemas.microsoft.com/office/drawing/2014/main" id="{DF095B08-3AC6-8841-4A66-30F62A3772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460679" y="6128917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12" name="Picture 111" descr="A graph with a red line&#10;&#10;Description automatically generated">
                <a:extLst>
                  <a:ext uri="{FF2B5EF4-FFF2-40B4-BE49-F238E27FC236}">
                    <a16:creationId xmlns:a16="http://schemas.microsoft.com/office/drawing/2014/main" id="{2D2DAA5F-6250-8B92-386D-EEAFC50695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466612" y="8449432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19" name="Picture 118" descr="A graph with a red line&#10;&#10;Description automatically generated">
                <a:extLst>
                  <a:ext uri="{FF2B5EF4-FFF2-40B4-BE49-F238E27FC236}">
                    <a16:creationId xmlns:a16="http://schemas.microsoft.com/office/drawing/2014/main" id="{56D8A0B8-9E1A-E153-DF4B-9E3C8513F28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446486" y="10768334"/>
                <a:ext cx="2320510" cy="2320510"/>
              </a:xfrm>
              <a:prstGeom prst="rect">
                <a:avLst/>
              </a:prstGeom>
            </p:spPr>
          </p:pic>
        </p:grpSp>
        <p:pic>
          <p:nvPicPr>
            <p:cNvPr id="3" name="Picture 2" descr="A blue circle with green lines&#10;&#10;Description automatically generated">
              <a:extLst>
                <a:ext uri="{FF2B5EF4-FFF2-40B4-BE49-F238E27FC236}">
                  <a16:creationId xmlns:a16="http://schemas.microsoft.com/office/drawing/2014/main" id="{92BD6D99-BE29-A2C2-59F8-40C019E0272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alphaModFix/>
            </a:blip>
            <a:stretch>
              <a:fillRect/>
            </a:stretch>
          </p:blipFill>
          <p:spPr>
            <a:xfrm>
              <a:off x="2258165" y="-2301347"/>
              <a:ext cx="2320510" cy="2320510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26BFD71-B206-E3B1-615D-5467537030A3}"/>
              </a:ext>
            </a:extLst>
          </p:cNvPr>
          <p:cNvGrpSpPr/>
          <p:nvPr/>
        </p:nvGrpSpPr>
        <p:grpSpPr>
          <a:xfrm>
            <a:off x="4468793" y="75132"/>
            <a:ext cx="2386164" cy="9253693"/>
            <a:chOff x="4459740" y="-2302308"/>
            <a:chExt cx="2386164" cy="9253693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548C51BE-ADD7-9DFD-9044-53B07B55D139}"/>
                </a:ext>
              </a:extLst>
            </p:cNvPr>
            <p:cNvGrpSpPr/>
            <p:nvPr/>
          </p:nvGrpSpPr>
          <p:grpSpPr>
            <a:xfrm>
              <a:off x="4459740" y="-12931"/>
              <a:ext cx="2386164" cy="6964316"/>
              <a:chOff x="3981907" y="1481025"/>
              <a:chExt cx="2386164" cy="6964316"/>
            </a:xfrm>
          </p:grpSpPr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7D796353-A88C-C655-99A0-494226405B81}"/>
                  </a:ext>
                </a:extLst>
              </p:cNvPr>
              <p:cNvSpPr txBox="1"/>
              <p:nvPr/>
            </p:nvSpPr>
            <p:spPr>
              <a:xfrm>
                <a:off x="4648848" y="3135896"/>
                <a:ext cx="107194" cy="2441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NP" dirty="0"/>
              </a:p>
            </p:txBody>
          </p:sp>
          <p:pic>
            <p:nvPicPr>
              <p:cNvPr id="110" name="Picture 109" descr="A blue circle with a red line&#10;&#10;Description automatically generated">
                <a:extLst>
                  <a:ext uri="{FF2B5EF4-FFF2-40B4-BE49-F238E27FC236}">
                    <a16:creationId xmlns:a16="http://schemas.microsoft.com/office/drawing/2014/main" id="{F8163FA7-5FE6-1921-6CD9-E3465E6F77D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047561" y="3801513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33" name="Picture 132" descr="A graph with a red line&#10;&#10;Description automatically generated">
                <a:extLst>
                  <a:ext uri="{FF2B5EF4-FFF2-40B4-BE49-F238E27FC236}">
                    <a16:creationId xmlns:a16="http://schemas.microsoft.com/office/drawing/2014/main" id="{30759241-4C1F-7213-75F4-0CCB3190FF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3985801" y="1481025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49" name="Picture 148" descr="A graph with a red line&#10;&#10;Description automatically generated">
                <a:extLst>
                  <a:ext uri="{FF2B5EF4-FFF2-40B4-BE49-F238E27FC236}">
                    <a16:creationId xmlns:a16="http://schemas.microsoft.com/office/drawing/2014/main" id="{A1C0FA15-DF23-B116-385C-C44C525938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981907" y="6124831"/>
                <a:ext cx="2320510" cy="2320510"/>
              </a:xfrm>
              <a:prstGeom prst="rect">
                <a:avLst/>
              </a:prstGeom>
            </p:spPr>
          </p:pic>
        </p:grpSp>
        <p:pic>
          <p:nvPicPr>
            <p:cNvPr id="5" name="Picture 4" descr="A graph with a red line&#10;&#10;Description automatically generated">
              <a:extLst>
                <a:ext uri="{FF2B5EF4-FFF2-40B4-BE49-F238E27FC236}">
                  <a16:creationId xmlns:a16="http://schemas.microsoft.com/office/drawing/2014/main" id="{63FAA3AF-1F63-312F-035B-00124C4FA3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alphaModFix/>
            </a:blip>
            <a:stretch>
              <a:fillRect/>
            </a:stretch>
          </p:blipFill>
          <p:spPr>
            <a:xfrm>
              <a:off x="4525124" y="-2302308"/>
              <a:ext cx="2320510" cy="232051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060038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587AC4-85C9-F672-4BFC-978C8EA3AE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58C042B-647C-E841-014B-51AF1C143309}"/>
              </a:ext>
            </a:extLst>
          </p:cNvPr>
          <p:cNvSpPr txBox="1"/>
          <p:nvPr/>
        </p:nvSpPr>
        <p:spPr>
          <a:xfrm>
            <a:off x="163915" y="9352002"/>
            <a:ext cx="67619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P" sz="1000" b="1" dirty="0"/>
              <a:t>Figure S1.</a:t>
            </a:r>
            <a:r>
              <a:rPr lang="en-NP" sz="1000" dirty="0"/>
              <a:t> </a:t>
            </a:r>
            <a:r>
              <a:rPr lang="en-US" sz="1000" dirty="0"/>
              <a:t>Continued….</a:t>
            </a:r>
            <a:endParaRPr lang="en-NP" sz="1000" dirty="0">
              <a:solidFill>
                <a:srgbClr val="FF0000"/>
              </a:solidFill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66462E4B-294B-7050-07C8-38433D245A2E}"/>
              </a:ext>
            </a:extLst>
          </p:cNvPr>
          <p:cNvGrpSpPr/>
          <p:nvPr/>
        </p:nvGrpSpPr>
        <p:grpSpPr>
          <a:xfrm>
            <a:off x="459382" y="47907"/>
            <a:ext cx="2379879" cy="9289942"/>
            <a:chOff x="459382" y="-2299053"/>
            <a:chExt cx="2379879" cy="9289942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6A9DC920-6C7E-FA18-8B3B-7389FF47B724}"/>
                </a:ext>
              </a:extLst>
            </p:cNvPr>
            <p:cNvGrpSpPr/>
            <p:nvPr/>
          </p:nvGrpSpPr>
          <p:grpSpPr>
            <a:xfrm>
              <a:off x="459382" y="23465"/>
              <a:ext cx="2379879" cy="6967424"/>
              <a:chOff x="6908681" y="-3162631"/>
              <a:chExt cx="2379879" cy="6967424"/>
            </a:xfrm>
          </p:grpSpPr>
          <p:pic>
            <p:nvPicPr>
              <p:cNvPr id="104" name="Picture 103" descr="A graph with a red line and a blue circle&#10;&#10;Description automatically generated with medium confidence">
                <a:extLst>
                  <a:ext uri="{FF2B5EF4-FFF2-40B4-BE49-F238E27FC236}">
                    <a16:creationId xmlns:a16="http://schemas.microsoft.com/office/drawing/2014/main" id="{4304199C-5786-9820-211D-97E6B4B2CD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908681" y="-3162631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14" name="Picture 113" descr="A graph with a red line&#10;&#10;Description automatically generated">
                <a:extLst>
                  <a:ext uri="{FF2B5EF4-FFF2-40B4-BE49-F238E27FC236}">
                    <a16:creationId xmlns:a16="http://schemas.microsoft.com/office/drawing/2014/main" id="{AFB372A6-5A93-605A-77F4-95C16C64AB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968050" y="1484283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17" name="Picture 116" descr="A blue circle with a red line&#10;&#10;Description automatically generated">
                <a:extLst>
                  <a:ext uri="{FF2B5EF4-FFF2-40B4-BE49-F238E27FC236}">
                    <a16:creationId xmlns:a16="http://schemas.microsoft.com/office/drawing/2014/main" id="{06650CF2-39D0-F278-6817-2B9F290AF2C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913948" y="-844708"/>
                <a:ext cx="2320510" cy="2320510"/>
              </a:xfrm>
              <a:prstGeom prst="rect">
                <a:avLst/>
              </a:prstGeom>
            </p:spPr>
          </p:pic>
        </p:grpSp>
        <p:pic>
          <p:nvPicPr>
            <p:cNvPr id="3" name="Picture 2" descr="A graph with a red line&#10;&#10;Description automatically generated">
              <a:extLst>
                <a:ext uri="{FF2B5EF4-FFF2-40B4-BE49-F238E27FC236}">
                  <a16:creationId xmlns:a16="http://schemas.microsoft.com/office/drawing/2014/main" id="{C80FACDA-6DA9-3049-5424-FB8137F1277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478874" y="-2299053"/>
              <a:ext cx="2320510" cy="2320510"/>
            </a:xfrm>
            <a:prstGeom prst="rect">
              <a:avLst/>
            </a:prstGeom>
          </p:spPr>
        </p:pic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5BF72614-0C3A-0598-43F3-624D8E08FD7C}"/>
              </a:ext>
            </a:extLst>
          </p:cNvPr>
          <p:cNvGrpSpPr/>
          <p:nvPr/>
        </p:nvGrpSpPr>
        <p:grpSpPr>
          <a:xfrm>
            <a:off x="2685449" y="30834"/>
            <a:ext cx="2364724" cy="9342887"/>
            <a:chOff x="2720559" y="-2316126"/>
            <a:chExt cx="2364724" cy="9342887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5410D59B-78E5-7E88-0003-625028F4BF9E}"/>
                </a:ext>
              </a:extLst>
            </p:cNvPr>
            <p:cNvGrpSpPr/>
            <p:nvPr/>
          </p:nvGrpSpPr>
          <p:grpSpPr>
            <a:xfrm>
              <a:off x="2720559" y="29130"/>
              <a:ext cx="2364724" cy="6997631"/>
              <a:chOff x="6869017" y="6130320"/>
              <a:chExt cx="2364724" cy="6997631"/>
            </a:xfrm>
          </p:grpSpPr>
          <p:pic>
            <p:nvPicPr>
              <p:cNvPr id="87" name="Picture 86" descr="A graph with a red line and blue dots&#10;&#10;Description automatically generated">
                <a:extLst>
                  <a:ext uri="{FF2B5EF4-FFF2-40B4-BE49-F238E27FC236}">
                    <a16:creationId xmlns:a16="http://schemas.microsoft.com/office/drawing/2014/main" id="{87656BE6-B026-3314-2EEC-FA2D0E4A54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913231" y="6130320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37" name="Picture 136" descr="A graph with a red line&#10;&#10;Description automatically generated">
                <a:extLst>
                  <a:ext uri="{FF2B5EF4-FFF2-40B4-BE49-F238E27FC236}">
                    <a16:creationId xmlns:a16="http://schemas.microsoft.com/office/drawing/2014/main" id="{36B28493-CD40-33C3-C6DB-A71BDCE94B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908682" y="8447824"/>
                <a:ext cx="2320510" cy="2320510"/>
              </a:xfrm>
              <a:prstGeom prst="rect">
                <a:avLst/>
              </a:prstGeom>
            </p:spPr>
          </p:pic>
          <p:pic>
            <p:nvPicPr>
              <p:cNvPr id="143" name="Picture 142" descr="A graph with a red line&#10;&#10;Description automatically generated">
                <a:extLst>
                  <a:ext uri="{FF2B5EF4-FFF2-40B4-BE49-F238E27FC236}">
                    <a16:creationId xmlns:a16="http://schemas.microsoft.com/office/drawing/2014/main" id="{E327C757-DECA-8814-84DB-DAD18C436E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869017" y="10807441"/>
                <a:ext cx="2320510" cy="2320510"/>
              </a:xfrm>
              <a:prstGeom prst="rect">
                <a:avLst/>
              </a:prstGeom>
            </p:spPr>
          </p:pic>
        </p:grpSp>
        <p:pic>
          <p:nvPicPr>
            <p:cNvPr id="4" name="Picture 3" descr="A graph with a red line&#10;&#10;Description automatically generated">
              <a:extLst>
                <a:ext uri="{FF2B5EF4-FFF2-40B4-BE49-F238E27FC236}">
                  <a16:creationId xmlns:a16="http://schemas.microsoft.com/office/drawing/2014/main" id="{4C9139BE-27B1-C5F9-9E43-EA68744E7E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alphaModFix/>
            </a:blip>
            <a:stretch>
              <a:fillRect/>
            </a:stretch>
          </p:blipFill>
          <p:spPr>
            <a:xfrm>
              <a:off x="2764408" y="-2316126"/>
              <a:ext cx="2320510" cy="232051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409890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oup 60">
            <a:extLst>
              <a:ext uri="{FF2B5EF4-FFF2-40B4-BE49-F238E27FC236}">
                <a16:creationId xmlns:a16="http://schemas.microsoft.com/office/drawing/2014/main" id="{223564F3-7A3C-2EE4-16D8-6187AD73EA17}"/>
              </a:ext>
            </a:extLst>
          </p:cNvPr>
          <p:cNvGrpSpPr/>
          <p:nvPr/>
        </p:nvGrpSpPr>
        <p:grpSpPr>
          <a:xfrm>
            <a:off x="142745" y="1878306"/>
            <a:ext cx="5044944" cy="5665227"/>
            <a:chOff x="142745" y="1878306"/>
            <a:chExt cx="5044944" cy="5665227"/>
          </a:xfrm>
        </p:grpSpPr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9CE29E61-5960-DD48-6F8E-71C84ADA788B}"/>
                </a:ext>
              </a:extLst>
            </p:cNvPr>
            <p:cNvSpPr/>
            <p:nvPr/>
          </p:nvSpPr>
          <p:spPr>
            <a:xfrm>
              <a:off x="640405" y="1878306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FAB863E7-7DB8-D5AE-9734-88C1F589A8A0}"/>
                </a:ext>
              </a:extLst>
            </p:cNvPr>
            <p:cNvSpPr/>
            <p:nvPr/>
          </p:nvSpPr>
          <p:spPr>
            <a:xfrm>
              <a:off x="260080" y="2270770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DE91BF30-ED1F-BB59-43CC-85A001C625B4}"/>
                </a:ext>
              </a:extLst>
            </p:cNvPr>
            <p:cNvSpPr/>
            <p:nvPr/>
          </p:nvSpPr>
          <p:spPr>
            <a:xfrm>
              <a:off x="603429" y="2347644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A51FF757-4101-FBDA-91C8-41F27BFC4AE0}"/>
                </a:ext>
              </a:extLst>
            </p:cNvPr>
            <p:cNvSpPr/>
            <p:nvPr/>
          </p:nvSpPr>
          <p:spPr>
            <a:xfrm>
              <a:off x="142745" y="2419670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F7AB489B-9B89-0CF2-B4CC-7D1E5B02F95E}"/>
                </a:ext>
              </a:extLst>
            </p:cNvPr>
            <p:cNvSpPr/>
            <p:nvPr/>
          </p:nvSpPr>
          <p:spPr>
            <a:xfrm>
              <a:off x="339544" y="4499323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5F7A1D0E-80CA-BA99-9131-197C57EDB143}"/>
                </a:ext>
              </a:extLst>
            </p:cNvPr>
            <p:cNvSpPr/>
            <p:nvPr/>
          </p:nvSpPr>
          <p:spPr>
            <a:xfrm>
              <a:off x="1877031" y="3390714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FEB9E197-6128-F389-0EBB-B37DB80EC5B8}"/>
                </a:ext>
              </a:extLst>
            </p:cNvPr>
            <p:cNvSpPr/>
            <p:nvPr/>
          </p:nvSpPr>
          <p:spPr>
            <a:xfrm>
              <a:off x="1618086" y="5191192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73337849-A0EE-34DA-31E2-8E9CEB6B0E14}"/>
                </a:ext>
              </a:extLst>
            </p:cNvPr>
            <p:cNvSpPr/>
            <p:nvPr/>
          </p:nvSpPr>
          <p:spPr>
            <a:xfrm>
              <a:off x="323360" y="535707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A8755995-9261-EF82-A2FC-FD5D42D0F3B8}"/>
                </a:ext>
              </a:extLst>
            </p:cNvPr>
            <p:cNvSpPr/>
            <p:nvPr/>
          </p:nvSpPr>
          <p:spPr>
            <a:xfrm>
              <a:off x="541845" y="629170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C28C4F1F-863E-488E-1168-F7F531033F25}"/>
                </a:ext>
              </a:extLst>
            </p:cNvPr>
            <p:cNvSpPr/>
            <p:nvPr/>
          </p:nvSpPr>
          <p:spPr>
            <a:xfrm>
              <a:off x="4211583" y="7274891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9F6C849B-D0F4-9328-F0C3-1274BC57D8AB}"/>
                </a:ext>
              </a:extLst>
            </p:cNvPr>
            <p:cNvSpPr/>
            <p:nvPr/>
          </p:nvSpPr>
          <p:spPr>
            <a:xfrm>
              <a:off x="4223722" y="537730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67041A8C-902A-B768-8CE8-01024FEC89AA}"/>
                </a:ext>
              </a:extLst>
            </p:cNvPr>
            <p:cNvSpPr/>
            <p:nvPr/>
          </p:nvSpPr>
          <p:spPr>
            <a:xfrm>
              <a:off x="4193096" y="3168183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C850702A-C2A2-58B9-2A37-6843FE31F0CD}"/>
                </a:ext>
              </a:extLst>
            </p:cNvPr>
            <p:cNvSpPr/>
            <p:nvPr/>
          </p:nvSpPr>
          <p:spPr>
            <a:xfrm>
              <a:off x="3319003" y="414953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842ECF0D-88D9-375E-2A17-B2948BB057E9}"/>
                </a:ext>
              </a:extLst>
            </p:cNvPr>
            <p:cNvSpPr/>
            <p:nvPr/>
          </p:nvSpPr>
          <p:spPr>
            <a:xfrm>
              <a:off x="4919047" y="497090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chemeClr val="accent2">
                    <a:lumMod val="75000"/>
                  </a:schemeClr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44CF5434-78B2-352C-FE28-8575E1774463}"/>
              </a:ext>
            </a:extLst>
          </p:cNvPr>
          <p:cNvGrpSpPr/>
          <p:nvPr/>
        </p:nvGrpSpPr>
        <p:grpSpPr>
          <a:xfrm>
            <a:off x="630857" y="2252912"/>
            <a:ext cx="5514586" cy="5585981"/>
            <a:chOff x="630857" y="2252912"/>
            <a:chExt cx="5514586" cy="5585981"/>
          </a:xfrm>
        </p:grpSpPr>
        <p:sp>
          <p:nvSpPr>
            <p:cNvPr id="63" name="Oval 62">
              <a:extLst>
                <a:ext uri="{FF2B5EF4-FFF2-40B4-BE49-F238E27FC236}">
                  <a16:creationId xmlns:a16="http://schemas.microsoft.com/office/drawing/2014/main" id="{BF8628C6-71EC-8764-6B23-CB2775D41FDA}"/>
                </a:ext>
              </a:extLst>
            </p:cNvPr>
            <p:cNvSpPr/>
            <p:nvPr/>
          </p:nvSpPr>
          <p:spPr>
            <a:xfrm>
              <a:off x="5341869" y="4418181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64" name="Oval 63">
              <a:extLst>
                <a:ext uri="{FF2B5EF4-FFF2-40B4-BE49-F238E27FC236}">
                  <a16:creationId xmlns:a16="http://schemas.microsoft.com/office/drawing/2014/main" id="{EF5C2C07-A6D0-7526-DF15-52B1EDC23BC3}"/>
                </a:ext>
              </a:extLst>
            </p:cNvPr>
            <p:cNvSpPr/>
            <p:nvPr/>
          </p:nvSpPr>
          <p:spPr>
            <a:xfrm>
              <a:off x="2230490" y="2558037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A4C87B07-4246-AE43-7E2B-8902CDB918FC}"/>
                </a:ext>
              </a:extLst>
            </p:cNvPr>
            <p:cNvSpPr/>
            <p:nvPr/>
          </p:nvSpPr>
          <p:spPr>
            <a:xfrm>
              <a:off x="982861" y="2743352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2D849AE7-7E0F-ACE1-CA1E-C9187EF1BEBA}"/>
                </a:ext>
              </a:extLst>
            </p:cNvPr>
            <p:cNvSpPr/>
            <p:nvPr/>
          </p:nvSpPr>
          <p:spPr>
            <a:xfrm>
              <a:off x="630857" y="3556601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67" name="Oval 66">
              <a:extLst>
                <a:ext uri="{FF2B5EF4-FFF2-40B4-BE49-F238E27FC236}">
                  <a16:creationId xmlns:a16="http://schemas.microsoft.com/office/drawing/2014/main" id="{5CAA892B-8495-9155-4C6B-5A4506E2A73F}"/>
                </a:ext>
              </a:extLst>
            </p:cNvPr>
            <p:cNvSpPr/>
            <p:nvPr/>
          </p:nvSpPr>
          <p:spPr>
            <a:xfrm>
              <a:off x="918125" y="448313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68" name="Oval 67">
              <a:extLst>
                <a:ext uri="{FF2B5EF4-FFF2-40B4-BE49-F238E27FC236}">
                  <a16:creationId xmlns:a16="http://schemas.microsoft.com/office/drawing/2014/main" id="{55B93B63-A895-A27D-9929-AF5C4C78B77B}"/>
                </a:ext>
              </a:extLst>
            </p:cNvPr>
            <p:cNvSpPr/>
            <p:nvPr/>
          </p:nvSpPr>
          <p:spPr>
            <a:xfrm>
              <a:off x="1868939" y="4058307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FF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69" name="Oval 68">
              <a:extLst>
                <a:ext uri="{FF2B5EF4-FFF2-40B4-BE49-F238E27FC236}">
                  <a16:creationId xmlns:a16="http://schemas.microsoft.com/office/drawing/2014/main" id="{DECAE9AB-7BE7-E447-B418-3B6FCBA4FAAD}"/>
                </a:ext>
              </a:extLst>
            </p:cNvPr>
            <p:cNvSpPr/>
            <p:nvPr/>
          </p:nvSpPr>
          <p:spPr>
            <a:xfrm>
              <a:off x="1019275" y="7088775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0" name="Oval 69">
              <a:extLst>
                <a:ext uri="{FF2B5EF4-FFF2-40B4-BE49-F238E27FC236}">
                  <a16:creationId xmlns:a16="http://schemas.microsoft.com/office/drawing/2014/main" id="{3CF77B5A-50CD-2F8B-1FAA-70B8E4ED7457}"/>
                </a:ext>
              </a:extLst>
            </p:cNvPr>
            <p:cNvSpPr/>
            <p:nvPr/>
          </p:nvSpPr>
          <p:spPr>
            <a:xfrm>
              <a:off x="2682188" y="7570251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1" name="Oval 70">
              <a:extLst>
                <a:ext uri="{FF2B5EF4-FFF2-40B4-BE49-F238E27FC236}">
                  <a16:creationId xmlns:a16="http://schemas.microsoft.com/office/drawing/2014/main" id="{D2247CB6-5740-E085-E7EB-20AE001B5598}"/>
                </a:ext>
              </a:extLst>
            </p:cNvPr>
            <p:cNvSpPr/>
            <p:nvPr/>
          </p:nvSpPr>
          <p:spPr>
            <a:xfrm>
              <a:off x="5000557" y="7323444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2" name="Oval 71">
              <a:extLst>
                <a:ext uri="{FF2B5EF4-FFF2-40B4-BE49-F238E27FC236}">
                  <a16:creationId xmlns:a16="http://schemas.microsoft.com/office/drawing/2014/main" id="{0F904AB7-9099-AE6E-E1B3-54326F2FF8A0}"/>
                </a:ext>
              </a:extLst>
            </p:cNvPr>
            <p:cNvSpPr/>
            <p:nvPr/>
          </p:nvSpPr>
          <p:spPr>
            <a:xfrm>
              <a:off x="5153435" y="5667751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3" name="Oval 72">
              <a:extLst>
                <a:ext uri="{FF2B5EF4-FFF2-40B4-BE49-F238E27FC236}">
                  <a16:creationId xmlns:a16="http://schemas.microsoft.com/office/drawing/2014/main" id="{FA4C8125-C53A-750B-CD03-C1EC57F39B2D}"/>
                </a:ext>
              </a:extLst>
            </p:cNvPr>
            <p:cNvSpPr/>
            <p:nvPr/>
          </p:nvSpPr>
          <p:spPr>
            <a:xfrm>
              <a:off x="5296788" y="408662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4" name="Oval 73">
              <a:extLst>
                <a:ext uri="{FF2B5EF4-FFF2-40B4-BE49-F238E27FC236}">
                  <a16:creationId xmlns:a16="http://schemas.microsoft.com/office/drawing/2014/main" id="{E242A3DE-FACF-AD43-D718-2D8A55CC2598}"/>
                </a:ext>
              </a:extLst>
            </p:cNvPr>
            <p:cNvSpPr/>
            <p:nvPr/>
          </p:nvSpPr>
          <p:spPr>
            <a:xfrm>
              <a:off x="4990723" y="2252912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5" name="Oval 74">
              <a:extLst>
                <a:ext uri="{FF2B5EF4-FFF2-40B4-BE49-F238E27FC236}">
                  <a16:creationId xmlns:a16="http://schemas.microsoft.com/office/drawing/2014/main" id="{C3E660CB-4FD9-60AA-0AD3-D173ECA2AE7E}"/>
                </a:ext>
              </a:extLst>
            </p:cNvPr>
            <p:cNvSpPr/>
            <p:nvPr/>
          </p:nvSpPr>
          <p:spPr>
            <a:xfrm>
              <a:off x="5876801" y="2689882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6" name="Oval 75">
              <a:extLst>
                <a:ext uri="{FF2B5EF4-FFF2-40B4-BE49-F238E27FC236}">
                  <a16:creationId xmlns:a16="http://schemas.microsoft.com/office/drawing/2014/main" id="{26FC0663-7DC8-DC3F-97DD-0A419CBB54A3}"/>
                </a:ext>
              </a:extLst>
            </p:cNvPr>
            <p:cNvSpPr/>
            <p:nvPr/>
          </p:nvSpPr>
          <p:spPr>
            <a:xfrm>
              <a:off x="2928996" y="3212690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7" name="Oval 76">
              <a:extLst>
                <a:ext uri="{FF2B5EF4-FFF2-40B4-BE49-F238E27FC236}">
                  <a16:creationId xmlns:a16="http://schemas.microsoft.com/office/drawing/2014/main" id="{179DF2C3-B168-4972-B26F-CEA37B9E1CC6}"/>
                </a:ext>
              </a:extLst>
            </p:cNvPr>
            <p:cNvSpPr/>
            <p:nvPr/>
          </p:nvSpPr>
          <p:spPr>
            <a:xfrm>
              <a:off x="3256724" y="257341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8" name="Oval 77">
              <a:extLst>
                <a:ext uri="{FF2B5EF4-FFF2-40B4-BE49-F238E27FC236}">
                  <a16:creationId xmlns:a16="http://schemas.microsoft.com/office/drawing/2014/main" id="{8BD61CA0-93C5-FFE7-D02D-5AE4B10C238F}"/>
                </a:ext>
              </a:extLst>
            </p:cNvPr>
            <p:cNvSpPr/>
            <p:nvPr/>
          </p:nvSpPr>
          <p:spPr>
            <a:xfrm>
              <a:off x="2878196" y="3825465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DB7EC098-1852-D03F-3236-F806ACDF2EDB}"/>
                </a:ext>
              </a:extLst>
            </p:cNvPr>
            <p:cNvSpPr/>
            <p:nvPr/>
          </p:nvSpPr>
          <p:spPr>
            <a:xfrm>
              <a:off x="4630038" y="4327929"/>
              <a:ext cx="268642" cy="268642"/>
            </a:xfrm>
            <a:prstGeom prst="ellipse">
              <a:avLst/>
            </a:prstGeom>
            <a:gradFill flip="none" rotWithShape="1">
              <a:gsLst>
                <a:gs pos="26000">
                  <a:schemeClr val="accent1">
                    <a:lumMod val="5000"/>
                    <a:lumOff val="95000"/>
                    <a:alpha val="58008"/>
                  </a:schemeClr>
                </a:gs>
                <a:gs pos="59000">
                  <a:srgbClr val="FF0000"/>
                </a:gs>
                <a:gs pos="84000">
                  <a:schemeClr val="accent5">
                    <a:lumMod val="40000"/>
                    <a:lumOff val="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175">
              <a:solidFill>
                <a:srgbClr val="C00000"/>
              </a:solidFill>
            </a:ln>
            <a:effectLst>
              <a:glow rad="63500">
                <a:schemeClr val="accent2">
                  <a:satMod val="175000"/>
                  <a:alpha val="40000"/>
                </a:schemeClr>
              </a:glo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P" dirty="0"/>
            </a:p>
          </p:txBody>
        </p:sp>
      </p:grpSp>
      <p:pic>
        <p:nvPicPr>
          <p:cNvPr id="45" name="Picture 44">
            <a:extLst>
              <a:ext uri="{FF2B5EF4-FFF2-40B4-BE49-F238E27FC236}">
                <a16:creationId xmlns:a16="http://schemas.microsoft.com/office/drawing/2014/main" id="{DFE60CFC-E528-3355-EE63-556FDBDC82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87552"/>
            <a:ext cx="6858000" cy="6330896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D817B63A-76B2-A5AF-746A-2F004568C620}"/>
              </a:ext>
            </a:extLst>
          </p:cNvPr>
          <p:cNvGrpSpPr/>
          <p:nvPr/>
        </p:nvGrpSpPr>
        <p:grpSpPr>
          <a:xfrm>
            <a:off x="620275" y="3366032"/>
            <a:ext cx="6227192" cy="5242880"/>
            <a:chOff x="620275" y="3366032"/>
            <a:chExt cx="6227192" cy="524288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2F5171B-44CF-0BBB-54B1-95A34139B1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20557" y="6381766"/>
              <a:ext cx="1326910" cy="222714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A880204-5407-8CA4-B1CB-7B126E413D3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27710" y="7480034"/>
              <a:ext cx="241489" cy="63499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69FDEF8-F1B9-6DBF-73F6-7BE7BEC6741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13686" y="3964676"/>
              <a:ext cx="180874" cy="69405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650D7D0-2228-8C69-78F6-A136F517A53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63755" y="3366032"/>
              <a:ext cx="199124" cy="66375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9696FB9-BDCF-0252-97E6-CA9D2BAFAD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50195"/>
            <a:stretch/>
          </p:blipFill>
          <p:spPr>
            <a:xfrm>
              <a:off x="1098184" y="7229921"/>
              <a:ext cx="104775" cy="55316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1468A50-D443-FD23-29AA-6C16545AAC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49375" t="3666" r="820" b="-3666"/>
            <a:stretch/>
          </p:blipFill>
          <p:spPr>
            <a:xfrm>
              <a:off x="2773421" y="7712224"/>
              <a:ext cx="104775" cy="55316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C443FF97-54C9-A953-8607-EE51E622946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99961" y="5337519"/>
              <a:ext cx="111615" cy="59408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2CC7A6C6-4935-F750-32D6-5AEB8FB88F1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292313" y="7420098"/>
              <a:ext cx="111615" cy="59408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297B3A69-E3F9-286E-1F58-AF0B654567D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201000" y="5919583"/>
              <a:ext cx="111615" cy="59408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B350522F-ABF9-A886-CE95-CCBD8717E6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-1" r="74233" b="17247"/>
            <a:stretch/>
          </p:blipFill>
          <p:spPr>
            <a:xfrm>
              <a:off x="620275" y="6432380"/>
              <a:ext cx="111125" cy="49485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6ED53828-99ED-D07D-347C-B51C16DD92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5788" t="21105" r="49916" b="-753"/>
            <a:stretch/>
          </p:blipFill>
          <p:spPr>
            <a:xfrm>
              <a:off x="1896588" y="7716069"/>
              <a:ext cx="104775" cy="47625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642575B1-CCF9-B157-E614-63F9405331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49510" t="19887" r="26194" b="463"/>
            <a:stretch/>
          </p:blipFill>
          <p:spPr>
            <a:xfrm>
              <a:off x="2446744" y="5769909"/>
              <a:ext cx="104775" cy="47625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F1C76787-5E54-7202-668B-F4CA15D824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75704" t="11902" b="8447"/>
            <a:stretch/>
          </p:blipFill>
          <p:spPr>
            <a:xfrm>
              <a:off x="1251503" y="5528669"/>
              <a:ext cx="104775" cy="47625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F99A502C-D57E-A295-C731-D4CBFF5EF8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572422" y="6481865"/>
              <a:ext cx="104775" cy="55768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1F93EE7A-9B3F-75C8-D6E0-CBEB3E1D33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b="50000"/>
            <a:stretch/>
          </p:blipFill>
          <p:spPr>
            <a:xfrm>
              <a:off x="2289443" y="6325589"/>
              <a:ext cx="112537" cy="56268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C51B6D9B-5294-CCA7-3DA1-34883520F3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t="51254" b="4866"/>
            <a:stretch/>
          </p:blipFill>
          <p:spPr>
            <a:xfrm>
              <a:off x="1060913" y="5482519"/>
              <a:ext cx="112537" cy="49381"/>
            </a:xfrm>
            <a:prstGeom prst="rect">
              <a:avLst/>
            </a:prstGeom>
          </p:spPr>
        </p:pic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235B069C-0616-6276-085F-6A75BFB4ED0C}"/>
              </a:ext>
            </a:extLst>
          </p:cNvPr>
          <p:cNvSpPr txBox="1"/>
          <p:nvPr/>
        </p:nvSpPr>
        <p:spPr>
          <a:xfrm>
            <a:off x="107010" y="8313573"/>
            <a:ext cx="531506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P" sz="1100" b="1" dirty="0"/>
              <a:t>Figure S2.</a:t>
            </a:r>
            <a:r>
              <a:rPr lang="en-NP" sz="1100" dirty="0"/>
              <a:t> Network of the TFs with potential physical association to the </a:t>
            </a:r>
            <a:r>
              <a:rPr lang="en-NP" sz="1100" i="1" dirty="0"/>
              <a:t>pMYB98</a:t>
            </a:r>
            <a:r>
              <a:rPr lang="en-NP" sz="1100" dirty="0"/>
              <a:t> binding members. Network was generated using IntAct</a:t>
            </a:r>
            <a:endParaRPr lang="en-NP" sz="1100" b="1" dirty="0"/>
          </a:p>
        </p:txBody>
      </p:sp>
    </p:spTree>
    <p:extLst>
      <p:ext uri="{BB962C8B-B14F-4D97-AF65-F5344CB8AC3E}">
        <p14:creationId xmlns:p14="http://schemas.microsoft.com/office/powerpoint/2010/main" val="22254691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BFF3D5ED-324F-1CA1-24B9-81AAC201598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9266"/>
          <a:stretch/>
        </p:blipFill>
        <p:spPr>
          <a:xfrm>
            <a:off x="49958" y="0"/>
            <a:ext cx="6849219" cy="70069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DA63D45-7522-80CF-881C-AEB600F722EF}"/>
              </a:ext>
            </a:extLst>
          </p:cNvPr>
          <p:cNvSpPr txBox="1"/>
          <p:nvPr/>
        </p:nvSpPr>
        <p:spPr>
          <a:xfrm>
            <a:off x="496024" y="6956731"/>
            <a:ext cx="3657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/>
              <a:t>Supplementary </a:t>
            </a:r>
            <a:r>
              <a:rPr lang="en-US" altLang="zh-CN" sz="1050" b="1"/>
              <a:t>Data S1 </a:t>
            </a:r>
            <a:r>
              <a:rPr lang="en-US" altLang="zh-CN" sz="1050" b="1" dirty="0"/>
              <a:t>[Higher-resolution version of Figure 7)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2573118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657</TotalTime>
  <Words>122</Words>
  <Application>Microsoft Office PowerPoint</Application>
  <PresentationFormat>A4 Paper (210x297 mm)</PresentationFormat>
  <Paragraphs>8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kash Babu Adhikari</dc:creator>
  <cp:lastModifiedBy>MDPI</cp:lastModifiedBy>
  <cp:revision>328</cp:revision>
  <cp:lastPrinted>2024-01-07T06:21:26Z</cp:lastPrinted>
  <dcterms:created xsi:type="dcterms:W3CDTF">2023-09-26T07:57:09Z</dcterms:created>
  <dcterms:modified xsi:type="dcterms:W3CDTF">2024-04-02T03:14:12Z</dcterms:modified>
</cp:coreProperties>
</file>